
<file path=[Content_Types].xml><?xml version="1.0" encoding="utf-8"?>
<Types xmlns="http://schemas.openxmlformats.org/package/2006/content-types">
  <Default Extension="emf" ContentType="image/x-emf"/>
  <Default Extension="jpg" ContentType="image/jpeg"/>
  <Default Extension="png" ContentType="image/png"/>
  <Default Extension="rels" ContentType="application/vnd.openxmlformats-package.relationships+xml"/>
  <Default Extension="tif" ContentType="image/png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3"/>
  </p:notesMasterIdLst>
  <p:sldIdLst>
    <p:sldId id="382" r:id="rId2"/>
    <p:sldId id="256" r:id="rId3"/>
    <p:sldId id="380" r:id="rId4"/>
    <p:sldId id="372" r:id="rId5"/>
    <p:sldId id="381" r:id="rId6"/>
    <p:sldId id="360" r:id="rId7"/>
    <p:sldId id="365" r:id="rId8"/>
    <p:sldId id="367" r:id="rId9"/>
    <p:sldId id="368" r:id="rId10"/>
    <p:sldId id="370" r:id="rId11"/>
    <p:sldId id="371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0902"/>
    <p:restoredTop sz="94690"/>
  </p:normalViewPr>
  <p:slideViewPr>
    <p:cSldViewPr snapToGrid="0" snapToObjects="1">
      <p:cViewPr varScale="1">
        <p:scale>
          <a:sx n="97" d="100"/>
          <a:sy n="97" d="100"/>
        </p:scale>
        <p:origin x="86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C32173-7B4B-A94B-A0DA-7AF59DBA1D2B}" type="datetimeFigureOut">
              <a:rPr lang="en-US" smtClean="0"/>
              <a:t>7/13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23A8B8D-C47C-0549-8185-A1DCE77EE4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94954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93FC39-4A59-F847-A160-750E1F77DA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3C1326D-81FF-594E-844F-0333F66C72C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CF2AFE-3A4B-4944-B72C-A9AE40BED1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1A2F7-B922-6C4E-9926-9D846DB2F26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EF6349-7AEC-3947-A90E-C5EFEDF19C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825752-EE74-E44C-91D8-350242A4D5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4DB55A-8FEC-464A-98D3-691D36457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9050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1EF8E5-F5B0-6244-9A4A-114E8252D4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8E87428-02CB-F241-A7AF-D395D37B11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076ABBE-57DA-8047-81F1-3B808C246A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1A2F7-B922-6C4E-9926-9D846DB2F26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A67D64-A442-A14D-8B68-0BD6A4F661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22C209-A8F7-0840-BCEA-151C63FEB8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4DB55A-8FEC-464A-98D3-691D36457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95881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3CECD59-F0F1-8D4B-871B-4EC25070BED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19C40A2-0AE0-0D4E-8FC1-FA238855D46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AD1D29-B0AB-7E4E-A8F7-52640413CB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1A2F7-B922-6C4E-9926-9D846DB2F26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9C0D641-6CCE-BE4D-BD7E-7845C1D3C9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A3D301-DA7D-7A44-B404-AAA7F3D6B2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4DB55A-8FEC-464A-98D3-691D36457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10179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15720B-7F51-9F45-AB37-BB9F57AA5C6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B34D4A1-A076-5549-895F-56411B8271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EC81E6C-D6C6-2C49-BA47-39ED0708B7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1A2F7-B922-6C4E-9926-9D846DB2F26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6508F1-1A7B-0B47-A41F-9C59D8ABF6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A29A69-A6CB-7944-A963-ACEDACAD20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4DB55A-8FEC-464A-98D3-691D36457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335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3E1819-C15C-234A-B0B7-0B6B0AC017A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81FA533-C714-1045-AD31-38815B93D7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C13D03-0EF3-3E45-A9C8-71A9AF76DF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1A2F7-B922-6C4E-9926-9D846DB2F26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C2352E-4447-F84A-98C8-D8BA3802F3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854663-4F0A-9C42-93E4-51C7AE114D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4DB55A-8FEC-464A-98D3-691D36457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2768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15AC56-80C3-0445-A1AB-9266E9694D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EA972C-43E5-5A49-81BB-FFE32353784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934D380-3A3D-9040-87EB-4202408731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556630-112B-9C48-8843-BCAD57EAE9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1A2F7-B922-6C4E-9926-9D846DB2F26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66520C2-7CDD-BC4A-9CEC-9DA444FE35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E7F10B4-C9F8-0A46-A731-3DCC7D302E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4DB55A-8FEC-464A-98D3-691D36457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8875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84D959-2496-D24F-8854-A50718DA05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B1D94B8-2A65-2C45-8BBB-07A3AFC01C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0EA215-7C41-8B45-91B0-CF1BEC21043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9E815D4-D29B-7943-ACCF-F3446DF0E88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859A0A1-8EC7-1D44-AD84-A659C216EAC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5F2B030-6573-E641-9C78-E18A69808B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1A2F7-B922-6C4E-9926-9D846DB2F26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BA6A93F-CF09-D245-8129-7F8870B41A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F96641C-BEBB-4C4A-B669-97BF92CE7A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4DB55A-8FEC-464A-98D3-691D36457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6757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1764CD-E926-334F-8437-21BABED286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D58C937-77BE-CD4E-894F-B7DB551F2E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1A2F7-B922-6C4E-9926-9D846DB2F26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A5BE676-81DB-2742-A6BF-30D38DC63D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F64258E-91DF-3C4F-BA8A-DC85485EC9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4DB55A-8FEC-464A-98D3-691D36457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94355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AD6537C-CE44-E640-83D1-0A6157B3EC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1A2F7-B922-6C4E-9926-9D846DB2F26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B0E8439-4CF7-A342-B6EA-9DD524A367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6F14AA9-03D1-914A-B572-E56CE24B51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4DB55A-8FEC-464A-98D3-691D36457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30549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DB7038-4423-004C-AB9F-2B5A859A01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4F41F1-5BB2-BD47-B1CB-FE9187B5B8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A5D4EC1-DA20-1843-AE0A-0D014B434B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D9A79F3-4A2B-C648-88C5-2055EE325D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1A2F7-B922-6C4E-9926-9D846DB2F26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616F42B-4AEB-4B42-924D-7B9E451004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6DAC8F-2BD1-DD45-89A3-C4741537D3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4DB55A-8FEC-464A-98D3-691D36457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80294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90929C-8D7F-AA47-8AA2-083085B574C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1B144BF-4B17-2540-9686-E7EF607E8E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70089C9-FC0F-D544-83E7-A8D72117AD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F518D1-0B41-9745-B39D-9D37B4F171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71A2F7-B922-6C4E-9926-9D846DB2F26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0D9082-5EDC-1745-9212-03DAFDC8FE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CA0791-A83A-6F47-90EE-5565F5AC83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4DB55A-8FEC-464A-98D3-691D36457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79981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0BC11C2-8055-3244-8931-4F6271709C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8B4ACE6-1B16-6F43-A406-9FB86947F86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6148D7-7E0E-3E46-9939-5A789175F19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71A2F7-B922-6C4E-9926-9D846DB2F264}" type="datetimeFigureOut">
              <a:rPr lang="en-US" smtClean="0"/>
              <a:t>7/13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79F9CD-984F-C243-A815-7FE5CAAAE45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D889D7-402C-4B47-A4AA-70F9B6325A0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4DB55A-8FEC-464A-98D3-691D36457F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74574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7.png"/><Relationship Id="rId4" Type="http://schemas.openxmlformats.org/officeDocument/2006/relationships/image" Target="../media/image6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1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emf"/><Relationship Id="rId3" Type="http://schemas.openxmlformats.org/officeDocument/2006/relationships/image" Target="../media/image16.emf"/><Relationship Id="rId7" Type="http://schemas.openxmlformats.org/officeDocument/2006/relationships/image" Target="../media/image20.emf"/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9.emf"/><Relationship Id="rId5" Type="http://schemas.openxmlformats.org/officeDocument/2006/relationships/image" Target="../media/image18.emf"/><Relationship Id="rId4" Type="http://schemas.openxmlformats.org/officeDocument/2006/relationships/image" Target="../media/image17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B3F1CD03-57BE-0448-80B0-2E6B3B7B474C}"/>
              </a:ext>
            </a:extLst>
          </p:cNvPr>
          <p:cNvSpPr txBox="1"/>
          <p:nvPr/>
        </p:nvSpPr>
        <p:spPr>
          <a:xfrm>
            <a:off x="6210208" y="939299"/>
            <a:ext cx="424576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1 Fig. </a:t>
            </a:r>
            <a:r>
              <a:rPr lang="en-US" sz="1200" dirty="0">
                <a:latin typeface="Arial" charset="0"/>
                <a:ea typeface="Arial" charset="0"/>
                <a:cs typeface="Arial" charset="0"/>
              </a:rPr>
              <a:t>Brightfield imaging is used to quantify number of cells in microwells. (A) Representative images of single MCF-7 and MDA-MB-231 cells settled in microwells with 30-μm diameter and 30-μm depth. Scale bar, 10 μm. (B) Percent of microwells containing MCF-7 and MDA-MB-231 cells. n</a:t>
            </a:r>
            <a:r>
              <a:rPr lang="en-US" sz="1200" baseline="-25000" dirty="0">
                <a:latin typeface="Arial" charset="0"/>
                <a:ea typeface="Arial" charset="0"/>
                <a:cs typeface="Arial" charset="0"/>
              </a:rPr>
              <a:t>MCF-7</a:t>
            </a:r>
            <a:r>
              <a:rPr lang="en-US" sz="1200" dirty="0">
                <a:latin typeface="Arial" charset="0"/>
                <a:ea typeface="Arial" charset="0"/>
                <a:cs typeface="Arial" charset="0"/>
              </a:rPr>
              <a:t> = 112 microwells, n</a:t>
            </a:r>
            <a:r>
              <a:rPr lang="en-US" sz="1200" baseline="-25000" dirty="0">
                <a:latin typeface="Arial" charset="0"/>
                <a:ea typeface="Arial" charset="0"/>
                <a:cs typeface="Arial" charset="0"/>
              </a:rPr>
              <a:t>MDA-MB-231</a:t>
            </a:r>
            <a:r>
              <a:rPr lang="en-US" sz="1200" dirty="0">
                <a:latin typeface="Arial" charset="0"/>
                <a:ea typeface="Arial" charset="0"/>
                <a:cs typeface="Arial" charset="0"/>
              </a:rPr>
              <a:t> = 158 microwells.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CFB2744C-1974-5B49-BAC6-2E41F7E97A63}"/>
              </a:ext>
            </a:extLst>
          </p:cNvPr>
          <p:cNvSpPr txBox="1"/>
          <p:nvPr/>
        </p:nvSpPr>
        <p:spPr>
          <a:xfrm>
            <a:off x="247043" y="177229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1 Fig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32023F23-2CD1-9C45-BF87-80CFB303CD8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0132" y="2047874"/>
            <a:ext cx="6134100" cy="33528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1098167F-0511-3C47-9E6F-1A38ABDBE8B0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388" t="6829" r="2160" b="4443"/>
          <a:stretch/>
        </p:blipFill>
        <p:spPr>
          <a:xfrm>
            <a:off x="1165227" y="1133475"/>
            <a:ext cx="850106" cy="914399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9FABFBC1-1F0E-7E4F-BC84-64361CA8237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193927" y="1133474"/>
            <a:ext cx="850106" cy="91440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B587C673-0AB8-1C43-9F73-13884CFA3A81}"/>
              </a:ext>
            </a:extLst>
          </p:cNvPr>
          <p:cNvSpPr txBox="1"/>
          <p:nvPr/>
        </p:nvSpPr>
        <p:spPr>
          <a:xfrm>
            <a:off x="1282343" y="893291"/>
            <a:ext cx="61587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CF-7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751CE27-411B-A540-8E5E-B6C75CAF1CC9}"/>
              </a:ext>
            </a:extLst>
          </p:cNvPr>
          <p:cNvSpPr txBox="1"/>
          <p:nvPr/>
        </p:nvSpPr>
        <p:spPr>
          <a:xfrm>
            <a:off x="2099446" y="893291"/>
            <a:ext cx="103906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MDA-MB-231</a:t>
            </a:r>
          </a:p>
        </p:txBody>
      </p: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1AD156ED-AC6C-8449-9436-9B89DD8B248F}"/>
              </a:ext>
            </a:extLst>
          </p:cNvPr>
          <p:cNvCxnSpPr/>
          <p:nvPr/>
        </p:nvCxnSpPr>
        <p:spPr>
          <a:xfrm>
            <a:off x="1881701" y="2092322"/>
            <a:ext cx="10972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E8DDEFE4-D257-8045-9647-EB09A3BCC49F}"/>
              </a:ext>
            </a:extLst>
          </p:cNvPr>
          <p:cNvCxnSpPr/>
          <p:nvPr/>
        </p:nvCxnSpPr>
        <p:spPr>
          <a:xfrm>
            <a:off x="2914097" y="2092322"/>
            <a:ext cx="10972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TextBox 23">
            <a:extLst>
              <a:ext uri="{FF2B5EF4-FFF2-40B4-BE49-F238E27FC236}">
                <a16:creationId xmlns:a16="http://schemas.microsoft.com/office/drawing/2014/main" id="{C2AA37D1-6A56-E14C-9550-8222ED1A2032}"/>
              </a:ext>
            </a:extLst>
          </p:cNvPr>
          <p:cNvSpPr txBox="1"/>
          <p:nvPr/>
        </p:nvSpPr>
        <p:spPr>
          <a:xfrm>
            <a:off x="1736029" y="2071778"/>
            <a:ext cx="4010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0 μm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88A2873E-B42F-D945-9893-EEA4C3709DF2}"/>
              </a:ext>
            </a:extLst>
          </p:cNvPr>
          <p:cNvSpPr txBox="1"/>
          <p:nvPr/>
        </p:nvSpPr>
        <p:spPr>
          <a:xfrm>
            <a:off x="2768425" y="2071778"/>
            <a:ext cx="40107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10 μm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DAD99CD-4D78-BB43-9902-883EE5C14AB0}"/>
              </a:ext>
            </a:extLst>
          </p:cNvPr>
          <p:cNvSpPr txBox="1"/>
          <p:nvPr/>
        </p:nvSpPr>
        <p:spPr>
          <a:xfrm>
            <a:off x="479427" y="711560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83AFE443-BD98-9A4D-AC79-D4D6BA63E7A6}"/>
              </a:ext>
            </a:extLst>
          </p:cNvPr>
          <p:cNvSpPr txBox="1"/>
          <p:nvPr/>
        </p:nvSpPr>
        <p:spPr>
          <a:xfrm>
            <a:off x="479427" y="2082475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10104679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9EF8A884-273C-284D-9A89-458A2C8CB635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118189326"/>
              </p:ext>
            </p:extLst>
          </p:nvPr>
        </p:nvGraphicFramePr>
        <p:xfrm>
          <a:off x="935625" y="338554"/>
          <a:ext cx="10320749" cy="612267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61334">
                  <a:extLst>
                    <a:ext uri="{9D8B030D-6E8A-4147-A177-3AD203B41FA5}">
                      <a16:colId xmlns:a16="http://schemas.microsoft.com/office/drawing/2014/main" val="3117509239"/>
                    </a:ext>
                  </a:extLst>
                </a:gridCol>
                <a:gridCol w="1690950">
                  <a:extLst>
                    <a:ext uri="{9D8B030D-6E8A-4147-A177-3AD203B41FA5}">
                      <a16:colId xmlns:a16="http://schemas.microsoft.com/office/drawing/2014/main" val="2781747431"/>
                    </a:ext>
                  </a:extLst>
                </a:gridCol>
                <a:gridCol w="1050468">
                  <a:extLst>
                    <a:ext uri="{9D8B030D-6E8A-4147-A177-3AD203B41FA5}">
                      <a16:colId xmlns:a16="http://schemas.microsoft.com/office/drawing/2014/main" val="3017098065"/>
                    </a:ext>
                  </a:extLst>
                </a:gridCol>
                <a:gridCol w="1757925">
                  <a:extLst>
                    <a:ext uri="{9D8B030D-6E8A-4147-A177-3AD203B41FA5}">
                      <a16:colId xmlns:a16="http://schemas.microsoft.com/office/drawing/2014/main" val="1314670816"/>
                    </a:ext>
                  </a:extLst>
                </a:gridCol>
                <a:gridCol w="1674892">
                  <a:extLst>
                    <a:ext uri="{9D8B030D-6E8A-4147-A177-3AD203B41FA5}">
                      <a16:colId xmlns:a16="http://schemas.microsoft.com/office/drawing/2014/main" val="1727138667"/>
                    </a:ext>
                  </a:extLst>
                </a:gridCol>
                <a:gridCol w="1393567">
                  <a:extLst>
                    <a:ext uri="{9D8B030D-6E8A-4147-A177-3AD203B41FA5}">
                      <a16:colId xmlns:a16="http://schemas.microsoft.com/office/drawing/2014/main" val="2204474208"/>
                    </a:ext>
                  </a:extLst>
                </a:gridCol>
                <a:gridCol w="1491613">
                  <a:extLst>
                    <a:ext uri="{9D8B030D-6E8A-4147-A177-3AD203B41FA5}">
                      <a16:colId xmlns:a16="http://schemas.microsoft.com/office/drawing/2014/main" val="821056838"/>
                    </a:ext>
                  </a:extLst>
                </a:gridCol>
              </a:tblGrid>
              <a:tr h="400844"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Typ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populatio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Targe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</a:t>
                      </a:r>
                    </a:p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2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</a:t>
                      </a:r>
                    </a:p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2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</a:p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 vs. TAM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istical Tes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42499"/>
                  </a:ext>
                </a:extLst>
              </a:tr>
              <a:tr h="400844">
                <a:tc rowSpan="10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F-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66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2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T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66</a:t>
                      </a:r>
                      <a:endParaRPr lang="en-US" sz="120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9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228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1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06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0.1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14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n-Whitney Tes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3276139"/>
                  </a:ext>
                </a:extLst>
              </a:tr>
              <a:tr h="400844">
                <a:tc vMerge="1">
                  <a:txBody>
                    <a:bodyPr/>
                    <a:lstStyle/>
                    <a:p>
                      <a:endParaRPr lang="en-US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66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2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T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T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9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228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3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06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4.6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7869775"/>
                  </a:ext>
                </a:extLst>
              </a:tr>
              <a:tr h="400844"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2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T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9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9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31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0.1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2673661"/>
                  </a:ext>
                </a:extLst>
              </a:tr>
              <a:tr h="400844">
                <a:tc vMerge="1">
                  <a:txBody>
                    <a:bodyPr/>
                    <a:lstStyle/>
                    <a:p>
                      <a:endParaRPr lang="en-US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2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T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T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9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9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7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30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2534031"/>
                  </a:ext>
                </a:extLst>
              </a:tr>
              <a:tr h="400844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p38 MAPK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5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219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38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0.1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26221859"/>
                  </a:ext>
                </a:extLst>
              </a:tr>
              <a:tr h="400844">
                <a:tc vMerge="1">
                  <a:txBody>
                    <a:bodyPr/>
                    <a:lstStyle/>
                    <a:p>
                      <a:pPr algn="ctr"/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p38 MAPK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38 MAPK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1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219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9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38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5319551"/>
                  </a:ext>
                </a:extLst>
              </a:tr>
              <a:tr h="400844">
                <a:tc vMerge="1">
                  <a:txBody>
                    <a:bodyPr/>
                    <a:lstStyle/>
                    <a:p>
                      <a:pPr algn="ctr"/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66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pS6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6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3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60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3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62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0.1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64020420"/>
                  </a:ext>
                </a:extLst>
              </a:tr>
              <a:tr h="400844">
                <a:tc vMerge="1">
                  <a:txBody>
                    <a:bodyPr/>
                    <a:lstStyle/>
                    <a:p>
                      <a:pPr algn="ctr"/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66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pS6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7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60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43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62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46897950"/>
                  </a:ext>
                </a:extLst>
              </a:tr>
              <a:tr h="400844">
                <a:tc vMerge="1">
                  <a:txBody>
                    <a:bodyPr/>
                    <a:lstStyle/>
                    <a:p>
                      <a:pPr algn="ctr"/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pS6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1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1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6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98444735"/>
                  </a:ext>
                </a:extLst>
              </a:tr>
              <a:tr h="400844">
                <a:tc vMerge="1">
                  <a:txBody>
                    <a:bodyPr/>
                    <a:lstStyle/>
                    <a:p>
                      <a:pPr algn="ctr"/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pS6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1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1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8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6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01238248"/>
                  </a:ext>
                </a:extLst>
              </a:tr>
              <a:tr h="427672">
                <a:tc rowSpan="4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A-MB-23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2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T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24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27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9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7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0.1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9186396"/>
                  </a:ext>
                </a:extLst>
              </a:tr>
              <a:tr h="427672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2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T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T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8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27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9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7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79996594"/>
                  </a:ext>
                </a:extLst>
              </a:tr>
              <a:tr h="400844"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D44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6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4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48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37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0884894"/>
                  </a:ext>
                </a:extLst>
              </a:tr>
              <a:tr h="400844"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D44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11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4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9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37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algn="ctr"/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0308097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996BE98A-859B-414A-9810-76192C9B418F}"/>
              </a:ext>
            </a:extLst>
          </p:cNvPr>
          <p:cNvSpPr txBox="1"/>
          <p:nvPr/>
        </p:nvSpPr>
        <p:spPr>
          <a:xfrm>
            <a:off x="36705" y="0"/>
            <a:ext cx="10125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S3 Table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292FEE8-8C37-DF47-A2F5-5A861E7CC366}"/>
              </a:ext>
            </a:extLst>
          </p:cNvPr>
          <p:cNvSpPr txBox="1"/>
          <p:nvPr/>
        </p:nvSpPr>
        <p:spPr>
          <a:xfrm>
            <a:off x="935625" y="6512026"/>
            <a:ext cx="70632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3 Tabl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AM effects on MCF-7 and MDA-MB-231 subpopulations expressing ER-α protein targets.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96992175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9EF8A884-273C-284D-9A89-458A2C8CB635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149454359"/>
              </p:ext>
            </p:extLst>
          </p:nvPr>
        </p:nvGraphicFramePr>
        <p:xfrm>
          <a:off x="628597" y="849648"/>
          <a:ext cx="10890467" cy="3956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36911">
                  <a:extLst>
                    <a:ext uri="{9D8B030D-6E8A-4147-A177-3AD203B41FA5}">
                      <a16:colId xmlns:a16="http://schemas.microsoft.com/office/drawing/2014/main" val="3117509239"/>
                    </a:ext>
                  </a:extLst>
                </a:gridCol>
                <a:gridCol w="869438">
                  <a:extLst>
                    <a:ext uri="{9D8B030D-6E8A-4147-A177-3AD203B41FA5}">
                      <a16:colId xmlns:a16="http://schemas.microsoft.com/office/drawing/2014/main" val="2464452584"/>
                    </a:ext>
                  </a:extLst>
                </a:gridCol>
                <a:gridCol w="1120887">
                  <a:extLst>
                    <a:ext uri="{9D8B030D-6E8A-4147-A177-3AD203B41FA5}">
                      <a16:colId xmlns:a16="http://schemas.microsoft.com/office/drawing/2014/main" val="1492330701"/>
                    </a:ext>
                  </a:extLst>
                </a:gridCol>
                <a:gridCol w="2518698">
                  <a:extLst>
                    <a:ext uri="{9D8B030D-6E8A-4147-A177-3AD203B41FA5}">
                      <a16:colId xmlns:a16="http://schemas.microsoft.com/office/drawing/2014/main" val="1314670816"/>
                    </a:ext>
                  </a:extLst>
                </a:gridCol>
                <a:gridCol w="2571446">
                  <a:extLst>
                    <a:ext uri="{9D8B030D-6E8A-4147-A177-3AD203B41FA5}">
                      <a16:colId xmlns:a16="http://schemas.microsoft.com/office/drawing/2014/main" val="435931707"/>
                    </a:ext>
                  </a:extLst>
                </a:gridCol>
                <a:gridCol w="1090491">
                  <a:extLst>
                    <a:ext uri="{9D8B030D-6E8A-4147-A177-3AD203B41FA5}">
                      <a16:colId xmlns:a16="http://schemas.microsoft.com/office/drawing/2014/main" val="2204474208"/>
                    </a:ext>
                  </a:extLst>
                </a:gridCol>
                <a:gridCol w="1582596">
                  <a:extLst>
                    <a:ext uri="{9D8B030D-6E8A-4147-A177-3AD203B41FA5}">
                      <a16:colId xmlns:a16="http://schemas.microsoft.com/office/drawing/2014/main" val="821056838"/>
                    </a:ext>
                  </a:extLst>
                </a:gridCol>
              </a:tblGrid>
              <a:tr h="400844">
                <a:tc>
                  <a:txBody>
                    <a:bodyPr/>
                    <a:lstStyle/>
                    <a:p>
                      <a:pPr algn="ctr"/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Typ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Targe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population 1 (</a:t>
                      </a:r>
                      <a:r>
                        <a:rPr lang="en-US" sz="105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bpopulation 2 (</a:t>
                      </a:r>
                      <a:r>
                        <a:rPr lang="en-US" sz="105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,</a:t>
                      </a:r>
                    </a:p>
                    <a:p>
                      <a:pPr algn="ctr"/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 vs. 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istical Tes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42499"/>
                  </a:ext>
                </a:extLst>
              </a:tr>
              <a:tr h="400844">
                <a:tc rowSpan="7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F-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T</a:t>
                      </a:r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6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5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T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3.63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06)</a:t>
                      </a:r>
                      <a:endParaRPr lang="en-US" sz="105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6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5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T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2.82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80)</a:t>
                      </a:r>
                      <a:endParaRPr lang="en-US" sz="105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</a:t>
                      </a:r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9">
                  <a:txBody>
                    <a:bodyPr/>
                    <a:lstStyle/>
                    <a:p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n-Whitney Tes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7869775"/>
                  </a:ext>
                </a:extLst>
              </a:tr>
              <a:tr h="400844"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6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6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5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T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0.91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06)</a:t>
                      </a:r>
                      <a:endParaRPr lang="en-US" sz="105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6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5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T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0.53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50)</a:t>
                      </a:r>
                      <a:endParaRPr lang="en-US" sz="105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</a:t>
                      </a:r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2673661"/>
                  </a:ext>
                </a:extLst>
              </a:tr>
              <a:tr h="400844">
                <a:tc vMerge="1">
                  <a:txBody>
                    <a:bodyPr/>
                    <a:lstStyle/>
                    <a:p>
                      <a:endParaRPr lang="en-US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5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T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1.37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30)</a:t>
                      </a:r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5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T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0.90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2)</a:t>
                      </a:r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</a:t>
                      </a:r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2534031"/>
                  </a:ext>
                </a:extLst>
              </a:tr>
              <a:tr h="385215">
                <a:tc vMerge="1">
                  <a:txBody>
                    <a:bodyPr/>
                    <a:lstStyle/>
                    <a:p>
                      <a:pPr algn="ctr"/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38 MAPK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6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p38 MAPK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1.89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38)</a:t>
                      </a:r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6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p38 MAPK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1.38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345)</a:t>
                      </a:r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2184313259"/>
                  </a:ext>
                </a:extLst>
              </a:tr>
              <a:tr h="385215">
                <a:tc vMerge="1">
                  <a:txBody>
                    <a:bodyPr/>
                    <a:lstStyle/>
                    <a:p>
                      <a:pPr algn="ctr"/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6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6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p38 MAPK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0.54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212)</a:t>
                      </a:r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6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p38 MAPK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0.62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2)</a:t>
                      </a:r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51385957"/>
                  </a:ext>
                </a:extLst>
              </a:tr>
              <a:tr h="385215">
                <a:tc vMerge="1">
                  <a:txBody>
                    <a:bodyPr/>
                    <a:lstStyle/>
                    <a:p>
                      <a:pPr algn="ctr"/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6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6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pS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1.13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62)</a:t>
                      </a:r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6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pS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0.56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94)</a:t>
                      </a:r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89865946"/>
                  </a:ext>
                </a:extLst>
              </a:tr>
              <a:tr h="385215">
                <a:tc vMerge="1">
                  <a:txBody>
                    <a:bodyPr/>
                    <a:lstStyle/>
                    <a:p>
                      <a:pPr algn="ctr"/>
                      <a:endParaRPr lang="en-US" sz="11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pS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1.73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5)</a:t>
                      </a:r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pS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0.95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27)</a:t>
                      </a:r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</a:t>
                      </a:r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39955289"/>
                  </a:ext>
                </a:extLst>
              </a:tr>
              <a:tr h="400844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A-MB-23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5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T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2.29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7)</a:t>
                      </a:r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US" sz="105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T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1.40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56)</a:t>
                      </a:r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</a:t>
                      </a:r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23701297"/>
                  </a:ext>
                </a:extLst>
              </a:tr>
              <a:tr h="400844"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D44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</a:t>
                      </a: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9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37)</a:t>
                      </a:r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CD44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3.34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05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245)</a:t>
                      </a:r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5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0.1 x 10</a:t>
                      </a:r>
                      <a:r>
                        <a:rPr lang="en-US" sz="105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</a:t>
                      </a:r>
                      <a:endParaRPr lang="en-US" sz="105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26785798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A3757EA2-5D14-E34A-9458-BE0B4036BB36}"/>
              </a:ext>
            </a:extLst>
          </p:cNvPr>
          <p:cNvSpPr txBox="1"/>
          <p:nvPr/>
        </p:nvSpPr>
        <p:spPr>
          <a:xfrm>
            <a:off x="36705" y="0"/>
            <a:ext cx="10125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S4 Table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149A0C6-EEA8-E348-88EB-18E4C351BA6E}"/>
              </a:ext>
            </a:extLst>
          </p:cNvPr>
          <p:cNvSpPr txBox="1"/>
          <p:nvPr/>
        </p:nvSpPr>
        <p:spPr>
          <a:xfrm>
            <a:off x="810863" y="6242447"/>
            <a:ext cx="73345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4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AM effects on MCF-7 and MDA-MB-231 subpopulations expressing ER-α protein targets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41601074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C89AEC6C-9F8C-2F45-85B1-0322D4EAE710}"/>
              </a:ext>
            </a:extLst>
          </p:cNvPr>
          <p:cNvSpPr txBox="1"/>
          <p:nvPr/>
        </p:nvSpPr>
        <p:spPr>
          <a:xfrm>
            <a:off x="7398576" y="936489"/>
            <a:ext cx="4245763" cy="36009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2 Fig. </a:t>
            </a:r>
            <a:r>
              <a:rPr lang="en-US" sz="1200" dirty="0">
                <a:latin typeface="Arial" charset="0"/>
                <a:ea typeface="Arial" charset="0"/>
                <a:cs typeface="Arial" charset="0"/>
              </a:rPr>
              <a:t>Quantitation of estrogen receptor α (ER-α) isoforms is limited by antibody selectivity and non-specificity. (A) An illustration of two ER isoforms (ER-α66, ER-α46) and ER-α antibody binding locations. Amino acid sequences of ER-α66 and ER-α46 are homologous except at the N-terminal AF1 transactivation domain. (B) Slab-gel western blotting with ER-α antibodies. Molecular sizing renders additional specificity to detect ER-α isoforms and non-specific signals. Out of the three antibodies, SP-1 distinctively revealed ER-α66 and ER-α46 in a MCF-7 lysate with 1 non-specific protein peak at a 100-kDa location, ER-α46 in a MDA-MB-231 lysate, and no ER-α66 in HEK293. (C) Confocal images of MCF-7 cells fixed and probed with ER-α antibodies. Scale bar, 50 µm. SP-1 and HC-20 stain align with nucleus staining (Hoechst 33342) for DNA in MCF-7. (D) Line histogram depicting number of cells with ER-α in fluorescence-activated cell sorting. With respect to HEK293, SP-1 identified 51% of MCF-7 cells expressing ER-α isoforms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173E8B5-FC7E-384B-B9FC-32185FCEB290}"/>
              </a:ext>
            </a:extLst>
          </p:cNvPr>
          <p:cNvSpPr txBox="1"/>
          <p:nvPr/>
        </p:nvSpPr>
        <p:spPr>
          <a:xfrm>
            <a:off x="247043" y="177229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2 Fig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718B7E65-C213-0C4B-AAA1-DBA80D3A5516}"/>
              </a:ext>
            </a:extLst>
          </p:cNvPr>
          <p:cNvGrpSpPr/>
          <p:nvPr/>
        </p:nvGrpSpPr>
        <p:grpSpPr>
          <a:xfrm>
            <a:off x="687840" y="714711"/>
            <a:ext cx="6399174" cy="5966060"/>
            <a:chOff x="942530" y="1010305"/>
            <a:chExt cx="3841967" cy="3581932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661025CE-8F47-604B-85E0-397F4783F18E}"/>
                </a:ext>
              </a:extLst>
            </p:cNvPr>
            <p:cNvGrpSpPr/>
            <p:nvPr/>
          </p:nvGrpSpPr>
          <p:grpSpPr>
            <a:xfrm>
              <a:off x="942530" y="1010305"/>
              <a:ext cx="3841967" cy="3347544"/>
              <a:chOff x="279921" y="3448705"/>
              <a:chExt cx="3841967" cy="3347544"/>
            </a:xfrm>
          </p:grpSpPr>
          <p:grpSp>
            <p:nvGrpSpPr>
              <p:cNvPr id="7" name="Group 6">
                <a:extLst>
                  <a:ext uri="{FF2B5EF4-FFF2-40B4-BE49-F238E27FC236}">
                    <a16:creationId xmlns:a16="http://schemas.microsoft.com/office/drawing/2014/main" id="{6F4A8DFB-2DA9-424F-AA0A-90D250205A63}"/>
                  </a:ext>
                </a:extLst>
              </p:cNvPr>
              <p:cNvGrpSpPr/>
              <p:nvPr/>
            </p:nvGrpSpPr>
            <p:grpSpPr>
              <a:xfrm>
                <a:off x="291001" y="4460857"/>
                <a:ext cx="1746286" cy="2335392"/>
                <a:chOff x="291001" y="4460857"/>
                <a:chExt cx="1746286" cy="2335392"/>
              </a:xfrm>
            </p:grpSpPr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1C4779E4-372B-1440-9141-88A610BFA5EC}"/>
                    </a:ext>
                  </a:extLst>
                </p:cNvPr>
                <p:cNvSpPr txBox="1"/>
                <p:nvPr/>
              </p:nvSpPr>
              <p:spPr>
                <a:xfrm>
                  <a:off x="291001" y="4460857"/>
                  <a:ext cx="124750" cy="240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2000" b="1" dirty="0">
                      <a:latin typeface="Arial" charset="0"/>
                      <a:ea typeface="Arial" charset="0"/>
                      <a:cs typeface="Arial" charset="0"/>
                    </a:rPr>
                    <a:t>C</a:t>
                  </a:r>
                </a:p>
              </p:txBody>
            </p:sp>
            <p:pic>
              <p:nvPicPr>
                <p:cNvPr id="16" name="Picture 15">
                  <a:extLst>
                    <a:ext uri="{FF2B5EF4-FFF2-40B4-BE49-F238E27FC236}">
                      <a16:creationId xmlns:a16="http://schemas.microsoft.com/office/drawing/2014/main" id="{EA37A2F6-1699-814B-A9B4-F4FC4A92CC5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53376" y="4527022"/>
                  <a:ext cx="1683911" cy="2269227"/>
                </a:xfrm>
                <a:prstGeom prst="rect">
                  <a:avLst/>
                </a:prstGeom>
              </p:spPr>
            </p:pic>
          </p:grpSp>
          <p:grpSp>
            <p:nvGrpSpPr>
              <p:cNvPr id="8" name="Group 7">
                <a:extLst>
                  <a:ext uri="{FF2B5EF4-FFF2-40B4-BE49-F238E27FC236}">
                    <a16:creationId xmlns:a16="http://schemas.microsoft.com/office/drawing/2014/main" id="{BE0D4E8D-1A9C-CE47-B114-A502DBEA2D5E}"/>
                  </a:ext>
                </a:extLst>
              </p:cNvPr>
              <p:cNvGrpSpPr/>
              <p:nvPr/>
            </p:nvGrpSpPr>
            <p:grpSpPr>
              <a:xfrm>
                <a:off x="279921" y="3449700"/>
                <a:ext cx="1879566" cy="869562"/>
                <a:chOff x="279921" y="3449700"/>
                <a:chExt cx="1879566" cy="869562"/>
              </a:xfrm>
            </p:grpSpPr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7815BAA5-AFA5-0F43-AE13-6F5229CFA0EB}"/>
                    </a:ext>
                  </a:extLst>
                </p:cNvPr>
                <p:cNvSpPr txBox="1"/>
                <p:nvPr/>
              </p:nvSpPr>
              <p:spPr>
                <a:xfrm>
                  <a:off x="279921" y="3449700"/>
                  <a:ext cx="124750" cy="240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2000" b="1" dirty="0">
                      <a:latin typeface="Arial" charset="0"/>
                      <a:ea typeface="Arial" charset="0"/>
                      <a:cs typeface="Arial" charset="0"/>
                    </a:rPr>
                    <a:t>A</a:t>
                  </a:r>
                </a:p>
              </p:txBody>
            </p:sp>
            <p:pic>
              <p:nvPicPr>
                <p:cNvPr id="14" name="Picture 13">
                  <a:extLst>
                    <a:ext uri="{FF2B5EF4-FFF2-40B4-BE49-F238E27FC236}">
                      <a16:creationId xmlns:a16="http://schemas.microsoft.com/office/drawing/2014/main" id="{E9574CD4-080F-AA4F-B728-C5B6E09A57A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74783" y="3539680"/>
                  <a:ext cx="1784704" cy="779582"/>
                </a:xfrm>
                <a:prstGeom prst="rect">
                  <a:avLst/>
                </a:prstGeom>
              </p:spPr>
            </p:pic>
          </p:grp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D1AEBE48-9B01-4040-9327-885A8506B8EC}"/>
                  </a:ext>
                </a:extLst>
              </p:cNvPr>
              <p:cNvGrpSpPr/>
              <p:nvPr/>
            </p:nvGrpSpPr>
            <p:grpSpPr>
              <a:xfrm>
                <a:off x="2209073" y="3448705"/>
                <a:ext cx="1912815" cy="1680237"/>
                <a:chOff x="272114" y="4401134"/>
                <a:chExt cx="1912815" cy="1680237"/>
              </a:xfrm>
            </p:grpSpPr>
            <p:sp>
              <p:nvSpPr>
                <p:cNvPr id="11" name="TextBox 10">
                  <a:extLst>
                    <a:ext uri="{FF2B5EF4-FFF2-40B4-BE49-F238E27FC236}">
                      <a16:creationId xmlns:a16="http://schemas.microsoft.com/office/drawing/2014/main" id="{C93ECE75-A74C-D742-BF8D-732D72A4AEAF}"/>
                    </a:ext>
                  </a:extLst>
                </p:cNvPr>
                <p:cNvSpPr txBox="1"/>
                <p:nvPr/>
              </p:nvSpPr>
              <p:spPr>
                <a:xfrm>
                  <a:off x="272114" y="4409242"/>
                  <a:ext cx="124750" cy="24022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sz="2000" b="1" dirty="0">
                      <a:latin typeface="Arial" charset="0"/>
                      <a:ea typeface="Arial" charset="0"/>
                      <a:cs typeface="Arial" charset="0"/>
                    </a:rPr>
                    <a:t>B</a:t>
                  </a:r>
                </a:p>
              </p:txBody>
            </p:sp>
            <p:pic>
              <p:nvPicPr>
                <p:cNvPr id="12" name="Picture 11">
                  <a:extLst>
                    <a:ext uri="{FF2B5EF4-FFF2-40B4-BE49-F238E27FC236}">
                      <a16:creationId xmlns:a16="http://schemas.microsoft.com/office/drawing/2014/main" id="{764360AD-F15B-1C46-9DB5-185E56F2308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 cstate="email">
                  <a:extLst>
                    <a:ext uri="{28A0092B-C50C-407E-A947-70E740481C1C}">
                      <a14:useLocalDpi xmlns:a14="http://schemas.microsoft.com/office/drawing/2010/main"/>
                    </a:ext>
                  </a:extLst>
                </a:blip>
                <a:srcRect l="15376" t="6603" r="6635" b="25872"/>
                <a:stretch/>
              </p:blipFill>
              <p:spPr>
                <a:xfrm>
                  <a:off x="409585" y="4401134"/>
                  <a:ext cx="1775344" cy="1680237"/>
                </a:xfrm>
                <a:prstGeom prst="rect">
                  <a:avLst/>
                </a:prstGeom>
              </p:spPr>
            </p:pic>
          </p:grp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326EB2C6-6848-1C4A-8834-28BB7B00E395}"/>
                  </a:ext>
                </a:extLst>
              </p:cNvPr>
              <p:cNvSpPr txBox="1"/>
              <p:nvPr/>
            </p:nvSpPr>
            <p:spPr>
              <a:xfrm>
                <a:off x="2209073" y="5128942"/>
                <a:ext cx="124750" cy="240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2000" b="1" dirty="0">
                    <a:latin typeface="Arial" charset="0"/>
                    <a:ea typeface="Arial" charset="0"/>
                    <a:cs typeface="Arial" charset="0"/>
                  </a:rPr>
                  <a:t>D</a:t>
                </a:r>
              </a:p>
            </p:txBody>
          </p:sp>
        </p:grpSp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1E20893D-483C-1846-9DEC-39DECA43586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871682" y="2756298"/>
              <a:ext cx="1854736" cy="183593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92494351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31998FF4-A580-EE41-B3F5-794C804093F0}"/>
              </a:ext>
            </a:extLst>
          </p:cNvPr>
          <p:cNvPicPr>
            <a:picLocks noChangeAspect="1"/>
          </p:cNvPicPr>
          <p:nvPr/>
        </p:nvPicPr>
        <p:blipFill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71007" y="177229"/>
            <a:ext cx="5095925" cy="657343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78775DE-32B0-8640-A71B-D26F0E11852B}"/>
              </a:ext>
            </a:extLst>
          </p:cNvPr>
          <p:cNvSpPr txBox="1"/>
          <p:nvPr/>
        </p:nvSpPr>
        <p:spPr>
          <a:xfrm>
            <a:off x="247043" y="177229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3 Fig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C5AC16E-0786-7C4C-86F7-393B441FA279}"/>
              </a:ext>
            </a:extLst>
          </p:cNvPr>
          <p:cNvSpPr txBox="1"/>
          <p:nvPr/>
        </p:nvSpPr>
        <p:spPr>
          <a:xfrm>
            <a:off x="6675230" y="315728"/>
            <a:ext cx="424576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3 Fig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ingle-cell immunoblotting detects ER-α66 and ER-α46. Grayscale micrographs show heterogeneity of ER-α66 (black arrow) and ER-α46 (red arrow) in 100 representative immunoblots.</a:t>
            </a:r>
            <a:endParaRPr lang="en-US" sz="1200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957167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2CACFB9C-E012-6643-9086-52B472A8C8C1}"/>
              </a:ext>
            </a:extLst>
          </p:cNvPr>
          <p:cNvPicPr/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31883" r="48941"/>
          <a:stretch/>
        </p:blipFill>
        <p:spPr>
          <a:xfrm>
            <a:off x="344384" y="870016"/>
            <a:ext cx="3603934" cy="341529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6DC6902D-E503-C042-ABD8-7A5BDF179D05}"/>
              </a:ext>
            </a:extLst>
          </p:cNvPr>
          <p:cNvPicPr/>
          <p:nvPr/>
        </p:nvPicPr>
        <p:blipFill rotWithShape="1">
          <a:blip r:embed="rId2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52788" t="5008"/>
          <a:stretch/>
        </p:blipFill>
        <p:spPr>
          <a:xfrm>
            <a:off x="3918329" y="809932"/>
            <a:ext cx="2522055" cy="360465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0D58EE5-3332-5A49-AAF1-DFFBD5A872D4}"/>
              </a:ext>
            </a:extLst>
          </p:cNvPr>
          <p:cNvSpPr txBox="1"/>
          <p:nvPr/>
        </p:nvSpPr>
        <p:spPr>
          <a:xfrm>
            <a:off x="442526" y="651300"/>
            <a:ext cx="28997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08E56A7-2849-6348-92A9-6705ED334C1B}"/>
              </a:ext>
            </a:extLst>
          </p:cNvPr>
          <p:cNvSpPr txBox="1"/>
          <p:nvPr/>
        </p:nvSpPr>
        <p:spPr>
          <a:xfrm>
            <a:off x="3773344" y="651300"/>
            <a:ext cx="28997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4CE2421F-FCED-104F-8FE3-0372E38A68B4}"/>
              </a:ext>
            </a:extLst>
          </p:cNvPr>
          <p:cNvSpPr/>
          <p:nvPr/>
        </p:nvSpPr>
        <p:spPr>
          <a:xfrm>
            <a:off x="6627322" y="651300"/>
            <a:ext cx="4052091" cy="58169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4 Fig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ingle-cell immunoblot with 1% SDS and 8M urea enables detection of ER-α66 and ER-α46 isoforms from hormone-sensitive (MCF-7) and hormone-insensitive (MDA-MB-231) breast cancer cell lines. (A) Characterization of solubility and electrophoretic separation of ER-α66 under different chemical lysis conditions. Increasing SDS concentration from 1% to 2% decreased separation resolution between ER-α66 and GAPDH from 0.73 to 0.41. The inclusion of 8M urea in the lysis buffer improved separation resolution of ER-α66 and GAPDH from 0.62 to 1.72 without diminishing SNR  Left: bar graphs show SDS and urea effects on separation resolution between ER-α66 and GAPDH (p &lt; 0.05, n</a:t>
            </a:r>
            <a:r>
              <a:rPr lang="en-US" sz="1200" baseline="-25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%SDS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= 31cells, n</a:t>
            </a:r>
            <a:r>
              <a:rPr lang="en-US" sz="1200" baseline="-25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%SDS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 97 cells, n</a:t>
            </a:r>
            <a:r>
              <a:rPr lang="en-US" sz="1200" baseline="-25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0MUrea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 22 cells, n</a:t>
            </a:r>
            <a:r>
              <a:rPr lang="en-US" sz="1200" baseline="-25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8MUrea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 209 cells, Mann-Whitney test). Right: box plots show SDS and urea effects on ER-α66 signal-to-noise ratio (p &lt; 0.05, n</a:t>
            </a:r>
            <a:r>
              <a:rPr lang="en-US" sz="1200" baseline="-25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1%SDS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= 31cells, n</a:t>
            </a:r>
            <a:r>
              <a:rPr lang="en-US" sz="1200" baseline="-25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2%SDS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 97 cells, n</a:t>
            </a:r>
            <a:r>
              <a:rPr lang="en-US" sz="1200" baseline="-25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0MUrea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 22 cells, n</a:t>
            </a:r>
            <a:r>
              <a:rPr lang="en-US" sz="1200" baseline="-250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8MUrea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= 209 cells, Mann-Whitney’s test). </a:t>
            </a:r>
            <a:r>
              <a:rPr lang="en-US" sz="1200" dirty="0">
                <a:solidFill>
                  <a:srgbClr val="000000"/>
                </a:solidFill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rror bars denote standard deviation.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(B) False-colored single-cell micrographs of ER-α isoforms detected with different ER-α antibodies from MCF-7, MDA-MB-231, and HEK293 cell lines. The SP-1 antibody distinguished ER-α66 and ER-α46 in the MCF-7 cells, without producing non-specific signals in any of the cell lines. (C) Scatter plots show population-averaged ER-</a:t>
            </a:r>
            <a:r>
              <a:rPr lang="el-GR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α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soform expression levels relative to </a:t>
            </a:r>
            <a:r>
              <a:rPr lang="el-GR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β-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UB in slab-gel immunoblotting. Each circle represents cells collected from a 10-cm cell culture dish. Red lines denote mean values. False-color western blots show protein peaks for ER-</a:t>
            </a:r>
            <a:r>
              <a:rPr lang="el-GR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α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isoforms and </a:t>
            </a:r>
            <a:r>
              <a:rPr lang="el-GR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β-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TUB from three replicates from the same passage number of MCF-7. </a:t>
            </a:r>
            <a:endParaRPr lang="en-US" sz="120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9C3ADE7-01B9-264C-8EE6-A71DEB1347A6}"/>
              </a:ext>
            </a:extLst>
          </p:cNvPr>
          <p:cNvSpPr txBox="1"/>
          <p:nvPr/>
        </p:nvSpPr>
        <p:spPr>
          <a:xfrm>
            <a:off x="247043" y="177229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4 Fig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5C0381BA-38F0-944D-863E-D202A35DE96C}"/>
              </a:ext>
            </a:extLst>
          </p:cNvPr>
          <p:cNvGrpSpPr/>
          <p:nvPr/>
        </p:nvGrpSpPr>
        <p:grpSpPr>
          <a:xfrm>
            <a:off x="1840226" y="4542316"/>
            <a:ext cx="1240465" cy="852303"/>
            <a:chOff x="1656318" y="4204037"/>
            <a:chExt cx="952232" cy="654263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3EB6ABDC-04D0-D448-BDA0-FF683ABAC2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75548" t="16989" b="41457"/>
            <a:stretch/>
          </p:blipFill>
          <p:spPr>
            <a:xfrm>
              <a:off x="1656318" y="4209790"/>
              <a:ext cx="931265" cy="648510"/>
            </a:xfrm>
            <a:prstGeom prst="rect">
              <a:avLst/>
            </a:prstGeom>
          </p:spPr>
        </p:pic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C07B7B0C-C5DA-2948-AA34-D1564797062B}"/>
                </a:ext>
              </a:extLst>
            </p:cNvPr>
            <p:cNvSpPr/>
            <p:nvPr/>
          </p:nvSpPr>
          <p:spPr>
            <a:xfrm>
              <a:off x="1980297" y="4204037"/>
              <a:ext cx="585642" cy="17314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548FE90F-5EE7-E349-AFB0-8CDAD52C71B9}"/>
                </a:ext>
              </a:extLst>
            </p:cNvPr>
            <p:cNvGrpSpPr/>
            <p:nvPr/>
          </p:nvGrpSpPr>
          <p:grpSpPr>
            <a:xfrm>
              <a:off x="1959100" y="4208030"/>
              <a:ext cx="649450" cy="200055"/>
              <a:chOff x="1954027" y="4184001"/>
              <a:chExt cx="649450" cy="200055"/>
            </a:xfrm>
          </p:grpSpPr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C233F70A-E22B-6C4D-AC97-23C0BAEEF16B}"/>
                  </a:ext>
                </a:extLst>
              </p:cNvPr>
              <p:cNvSpPr txBox="1"/>
              <p:nvPr/>
            </p:nvSpPr>
            <p:spPr>
              <a:xfrm>
                <a:off x="1954027" y="4184001"/>
                <a:ext cx="2343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FA4C6D70-B4BF-A948-8445-2415EC5335A2}"/>
                  </a:ext>
                </a:extLst>
              </p:cNvPr>
              <p:cNvSpPr txBox="1"/>
              <p:nvPr/>
            </p:nvSpPr>
            <p:spPr>
              <a:xfrm>
                <a:off x="2161572" y="4184001"/>
                <a:ext cx="2343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FCBF152B-87F9-494C-8B70-02E2A4BCDEF6}"/>
                  </a:ext>
                </a:extLst>
              </p:cNvPr>
              <p:cNvSpPr txBox="1"/>
              <p:nvPr/>
            </p:nvSpPr>
            <p:spPr>
              <a:xfrm>
                <a:off x="2369117" y="4184001"/>
                <a:ext cx="234360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</a:p>
            </p:txBody>
          </p:sp>
        </p:grpSp>
      </p:grpSp>
      <p:pic>
        <p:nvPicPr>
          <p:cNvPr id="19" name="Picture 18">
            <a:extLst>
              <a:ext uri="{FF2B5EF4-FFF2-40B4-BE49-F238E27FC236}">
                <a16:creationId xmlns:a16="http://schemas.microsoft.com/office/drawing/2014/main" id="{B9CD57D8-EFFD-6349-9231-DCA4BF520A9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22297" y="4483671"/>
            <a:ext cx="2438400" cy="2197100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6256BB6D-CEA7-6D4E-91CF-A051C0AEB650}"/>
              </a:ext>
            </a:extLst>
          </p:cNvPr>
          <p:cNvSpPr txBox="1"/>
          <p:nvPr/>
        </p:nvSpPr>
        <p:spPr>
          <a:xfrm>
            <a:off x="442526" y="4285313"/>
            <a:ext cx="28997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95990067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0">
            <a:extLst>
              <a:ext uri="{FF2B5EF4-FFF2-40B4-BE49-F238E27FC236}">
                <a16:creationId xmlns:a16="http://schemas.microsoft.com/office/drawing/2014/main" id="{CF9D4C8F-ED1F-CD48-9F61-5B4399CA3D9F}"/>
              </a:ext>
            </a:extLst>
          </p:cNvPr>
          <p:cNvSpPr txBox="1"/>
          <p:nvPr/>
        </p:nvSpPr>
        <p:spPr>
          <a:xfrm>
            <a:off x="247043" y="177229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5 Fig</a:t>
            </a:r>
          </a:p>
        </p:txBody>
      </p:sp>
      <p:sp>
        <p:nvSpPr>
          <p:cNvPr id="42" name="Rectangle 41">
            <a:extLst>
              <a:ext uri="{FF2B5EF4-FFF2-40B4-BE49-F238E27FC236}">
                <a16:creationId xmlns:a16="http://schemas.microsoft.com/office/drawing/2014/main" id="{38B42922-B1E0-9D4A-9F23-9230AFCBAFC0}"/>
              </a:ext>
            </a:extLst>
          </p:cNvPr>
          <p:cNvSpPr/>
          <p:nvPr/>
        </p:nvSpPr>
        <p:spPr>
          <a:xfrm>
            <a:off x="5936643" y="705177"/>
            <a:ext cx="5564678" cy="34163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S5 Fig. </a:t>
            </a:r>
            <a:r>
              <a:rPr lang="en-US" sz="1200" dirty="0"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Estradiol (E2) effects on hormone-sensitive MCF-7 (A-C) and hormone-insensitive MDA-MB-231 (D-E)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(A) Top: Scatter plots indicate that mean ER-α66 expression level is increased in ER-α66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ubpopulation by E2 (***p &lt; 0.0001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 604, n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E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= 149, Mann-Whitney test). Bottom: scatter plots show that E2 increases mean ER-α46 expression level (***p &lt; 0.0001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= 38, n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E2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50, Mann-Whitney test). (B) Stacked bar graphs show E2 repression on the type 2 subpopulation frequencies (μ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neg_type2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 63.5, μ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E2_type2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 18.8, ***p &lt; 0.0001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 n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E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= 3 devices, Mann-Whitney test) yet having no significant effects on the types 1 frequency (μ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neg_type1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 5.5, μ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E2_type1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 12, p &gt; 0.3, Mann-Whitney test). (C) Scatter plots of ER-α66 and ER-α46 expression in the type 1 subpopulation indicate that cells with E2 express high ER-α46. ER-α66 expression in the type 1 subpopulation is increased in E2. Circles denote cells without treatment. Squares denote cells with E2.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 26 cells, n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E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= 20 cells). (D) In MDA-MB-231, E2 does not significantly affect ER-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46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xpression (ns: p = 0.06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= 36 cells, n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E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= 50 cells, Mann-Whitney test). (E) Stacked bar graphs show MDA-MB-231 frequencies in response to E2. TAM significantly increased the frequency of cells classified as the type 1 MDA-MB-231 subpopulation (p = 0.01,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latin typeface="Arial" panose="020B0604020202020204" pitchFamily="34" charset="0"/>
                <a:cs typeface="Arial" panose="020B0604020202020204" pitchFamily="34" charset="0"/>
              </a:rPr>
              <a:t>ne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= n</a:t>
            </a:r>
            <a:r>
              <a:rPr lang="en-US" sz="1200" baseline="-25000" dirty="0">
                <a:latin typeface="Arial" panose="020B0604020202020204" pitchFamily="34" charset="0"/>
                <a:cs typeface="Arial" panose="020B0604020202020204" pitchFamily="34" charset="0"/>
              </a:rPr>
              <a:t>E2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= 3 devices, Mann-Whitney test). 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3D34D41-D9CF-C645-AC52-EBFFB5F130B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1010" y="705177"/>
            <a:ext cx="5016500" cy="5461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0010221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9A9002B-BA8C-AF44-852E-6C211F2D1EA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r="73014"/>
          <a:stretch/>
        </p:blipFill>
        <p:spPr>
          <a:xfrm>
            <a:off x="161788" y="452749"/>
            <a:ext cx="1156373" cy="6244451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4424E21-FD30-1446-8293-E915110C7A32}"/>
              </a:ext>
            </a:extLst>
          </p:cNvPr>
          <p:cNvSpPr txBox="1"/>
          <p:nvPr/>
        </p:nvSpPr>
        <p:spPr>
          <a:xfrm>
            <a:off x="0" y="0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6 Fig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ECC40982-BBC0-B742-8B01-154B27DCAEF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73038"/>
          <a:stretch/>
        </p:blipFill>
        <p:spPr>
          <a:xfrm>
            <a:off x="3647734" y="285913"/>
            <a:ext cx="1155338" cy="6411287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84DDE87-748A-9A4A-ABAA-0D292C5122F5}"/>
              </a:ext>
            </a:extLst>
          </p:cNvPr>
          <p:cNvSpPr txBox="1"/>
          <p:nvPr/>
        </p:nvSpPr>
        <p:spPr>
          <a:xfrm>
            <a:off x="48501" y="452748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A59DD95-8489-E147-9249-EF1B391C4AB0}"/>
              </a:ext>
            </a:extLst>
          </p:cNvPr>
          <p:cNvSpPr txBox="1"/>
          <p:nvPr/>
        </p:nvSpPr>
        <p:spPr>
          <a:xfrm>
            <a:off x="3460191" y="452748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2497949-3CF0-8047-AB4C-0FEBA96FC209}"/>
              </a:ext>
            </a:extLst>
          </p:cNvPr>
          <p:cNvSpPr txBox="1"/>
          <p:nvPr/>
        </p:nvSpPr>
        <p:spPr>
          <a:xfrm>
            <a:off x="7806487" y="1093848"/>
            <a:ext cx="329823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6 Fig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AM treatment effects on subpopulations expressing ER-α signaling proteins in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) MCF-7 and (B) MDA-MB-231 cells. Red lines denote mean values. Kruskal-Wallis test with Dunn’s multiple comparison, ns: p &gt; 0.05, *p &lt; 0.05, **p &lt; 0.001, ***p , 0.0001). </a:t>
            </a:r>
          </a:p>
          <a:p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79AB0EB4-130C-E247-A7FA-88328F59A28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7539" r="48604"/>
          <a:stretch/>
        </p:blipFill>
        <p:spPr>
          <a:xfrm>
            <a:off x="1306287" y="452749"/>
            <a:ext cx="593766" cy="624445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E347F460-73D7-514E-A38E-9D81ECBFAD24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50830" r="23673"/>
          <a:stretch/>
        </p:blipFill>
        <p:spPr>
          <a:xfrm>
            <a:off x="1916395" y="452749"/>
            <a:ext cx="1092530" cy="6244451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B424689-E276-CC4F-A0D7-0DB4A9720B6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84712" r="2863"/>
          <a:stretch/>
        </p:blipFill>
        <p:spPr>
          <a:xfrm>
            <a:off x="2927768" y="452749"/>
            <a:ext cx="532423" cy="6244451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F71B32AB-4D5A-374A-8B0D-7D8F796097C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37662" r="50083"/>
          <a:stretch/>
        </p:blipFill>
        <p:spPr>
          <a:xfrm>
            <a:off x="4784876" y="285913"/>
            <a:ext cx="525157" cy="6411287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CC603CCD-5A89-A949-9730-119F33AADF1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0274" r="26145"/>
          <a:stretch/>
        </p:blipFill>
        <p:spPr>
          <a:xfrm>
            <a:off x="5456326" y="285913"/>
            <a:ext cx="1010493" cy="6411287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22F8667B-C3DF-E746-951F-DD78F35B0B4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84811" r="1609"/>
          <a:stretch/>
        </p:blipFill>
        <p:spPr>
          <a:xfrm>
            <a:off x="6453882" y="285913"/>
            <a:ext cx="581891" cy="6411287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5E34D69C-2C35-0341-8519-FC29426E56A4}"/>
              </a:ext>
            </a:extLst>
          </p:cNvPr>
          <p:cNvSpPr/>
          <p:nvPr/>
        </p:nvSpPr>
        <p:spPr>
          <a:xfrm>
            <a:off x="1080736" y="788039"/>
            <a:ext cx="468452" cy="26650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E7385F18-9DC0-F14B-9855-E7998C3164AB}"/>
              </a:ext>
            </a:extLst>
          </p:cNvPr>
          <p:cNvSpPr/>
          <p:nvPr/>
        </p:nvSpPr>
        <p:spPr>
          <a:xfrm>
            <a:off x="2719004" y="832815"/>
            <a:ext cx="468452" cy="266505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C7DF4047-6A1F-4240-A223-F1F8D2B15CE4}"/>
              </a:ext>
            </a:extLst>
          </p:cNvPr>
          <p:cNvSpPr/>
          <p:nvPr/>
        </p:nvSpPr>
        <p:spPr>
          <a:xfrm>
            <a:off x="4597333" y="621417"/>
            <a:ext cx="468452" cy="19807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A9AEBE24-DF14-6049-BB0C-A303AC20649E}"/>
              </a:ext>
            </a:extLst>
          </p:cNvPr>
          <p:cNvSpPr/>
          <p:nvPr/>
        </p:nvSpPr>
        <p:spPr>
          <a:xfrm>
            <a:off x="6232144" y="634743"/>
            <a:ext cx="468452" cy="15329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97D8806F-1501-4443-8182-EE1581B9DBE2}"/>
              </a:ext>
            </a:extLst>
          </p:cNvPr>
          <p:cNvSpPr/>
          <p:nvPr/>
        </p:nvSpPr>
        <p:spPr>
          <a:xfrm>
            <a:off x="2719004" y="2233338"/>
            <a:ext cx="468452" cy="1294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76EE16C2-AA6D-4640-AE1C-86EA3E8A8B9A}"/>
              </a:ext>
            </a:extLst>
          </p:cNvPr>
          <p:cNvSpPr/>
          <p:nvPr/>
        </p:nvSpPr>
        <p:spPr>
          <a:xfrm>
            <a:off x="4597333" y="2055734"/>
            <a:ext cx="468452" cy="1980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DF0B0E2F-9763-D143-B5C9-8E8CFF9EAEBF}"/>
              </a:ext>
            </a:extLst>
          </p:cNvPr>
          <p:cNvSpPr/>
          <p:nvPr/>
        </p:nvSpPr>
        <p:spPr>
          <a:xfrm>
            <a:off x="6229645" y="2114280"/>
            <a:ext cx="468452" cy="19807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3E368B1D-0F0A-DD46-B300-E72B8214A004}"/>
              </a:ext>
            </a:extLst>
          </p:cNvPr>
          <p:cNvSpPr/>
          <p:nvPr/>
        </p:nvSpPr>
        <p:spPr>
          <a:xfrm>
            <a:off x="1072020" y="3624229"/>
            <a:ext cx="468452" cy="18693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C4AFE760-6BFE-D748-A129-F48A82687AC1}"/>
              </a:ext>
            </a:extLst>
          </p:cNvPr>
          <p:cNvSpPr/>
          <p:nvPr/>
        </p:nvSpPr>
        <p:spPr>
          <a:xfrm>
            <a:off x="2718853" y="3690972"/>
            <a:ext cx="468452" cy="2136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DCBD2820-7C9B-D84F-B0B9-6C5A8ED8BFF3}"/>
              </a:ext>
            </a:extLst>
          </p:cNvPr>
          <p:cNvSpPr/>
          <p:nvPr/>
        </p:nvSpPr>
        <p:spPr>
          <a:xfrm>
            <a:off x="4597333" y="3590817"/>
            <a:ext cx="468452" cy="2136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CD8F9005-115A-5B44-8D05-143C8CD9BBDC}"/>
              </a:ext>
            </a:extLst>
          </p:cNvPr>
          <p:cNvSpPr/>
          <p:nvPr/>
        </p:nvSpPr>
        <p:spPr>
          <a:xfrm>
            <a:off x="6237738" y="3590817"/>
            <a:ext cx="468452" cy="2136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992A3FA2-D452-8D46-B242-BEEF40DCBA18}"/>
              </a:ext>
            </a:extLst>
          </p:cNvPr>
          <p:cNvSpPr/>
          <p:nvPr/>
        </p:nvSpPr>
        <p:spPr>
          <a:xfrm>
            <a:off x="2728404" y="5152754"/>
            <a:ext cx="468452" cy="2136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0467C467-1960-D441-9923-F1BF4DB04FED}"/>
              </a:ext>
            </a:extLst>
          </p:cNvPr>
          <p:cNvSpPr/>
          <p:nvPr/>
        </p:nvSpPr>
        <p:spPr>
          <a:xfrm>
            <a:off x="1078758" y="5192798"/>
            <a:ext cx="468452" cy="2136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F6361F48-C0F8-7845-9A9D-85C5777C30EB}"/>
              </a:ext>
            </a:extLst>
          </p:cNvPr>
          <p:cNvSpPr/>
          <p:nvPr/>
        </p:nvSpPr>
        <p:spPr>
          <a:xfrm>
            <a:off x="4587902" y="5199622"/>
            <a:ext cx="468452" cy="2136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25D44F7E-7DDC-5D49-8058-9F9828FA1499}"/>
              </a:ext>
            </a:extLst>
          </p:cNvPr>
          <p:cNvSpPr/>
          <p:nvPr/>
        </p:nvSpPr>
        <p:spPr>
          <a:xfrm>
            <a:off x="6221820" y="5199815"/>
            <a:ext cx="468452" cy="21365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B8297ED-2A0D-7546-93C6-DF562638C9EC}"/>
              </a:ext>
            </a:extLst>
          </p:cNvPr>
          <p:cNvSpPr txBox="1"/>
          <p:nvPr/>
        </p:nvSpPr>
        <p:spPr>
          <a:xfrm>
            <a:off x="1199391" y="591248"/>
            <a:ext cx="2391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477B4A1-35D9-C64E-B5BA-086D7F4EF620}"/>
              </a:ext>
            </a:extLst>
          </p:cNvPr>
          <p:cNvSpPr txBox="1"/>
          <p:nvPr/>
        </p:nvSpPr>
        <p:spPr>
          <a:xfrm>
            <a:off x="1144889" y="3412576"/>
            <a:ext cx="34817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8106E10-3FE6-9A4F-A35E-94547096C2B4}"/>
              </a:ext>
            </a:extLst>
          </p:cNvPr>
          <p:cNvSpPr txBox="1"/>
          <p:nvPr/>
        </p:nvSpPr>
        <p:spPr>
          <a:xfrm>
            <a:off x="1152102" y="4934686"/>
            <a:ext cx="3337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7AC571A8-EDC1-0341-B89E-502D05ABD8ED}"/>
              </a:ext>
            </a:extLst>
          </p:cNvPr>
          <p:cNvSpPr txBox="1"/>
          <p:nvPr/>
        </p:nvSpPr>
        <p:spPr>
          <a:xfrm>
            <a:off x="2785699" y="557879"/>
            <a:ext cx="3337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5AE65128-79C8-2348-AE3E-35AF1865AC56}"/>
              </a:ext>
            </a:extLst>
          </p:cNvPr>
          <p:cNvSpPr txBox="1"/>
          <p:nvPr/>
        </p:nvSpPr>
        <p:spPr>
          <a:xfrm>
            <a:off x="2785699" y="1958218"/>
            <a:ext cx="3337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FF6F7CF8-1922-AA4E-941F-98C968168972}"/>
              </a:ext>
            </a:extLst>
          </p:cNvPr>
          <p:cNvSpPr txBox="1"/>
          <p:nvPr/>
        </p:nvSpPr>
        <p:spPr>
          <a:xfrm>
            <a:off x="2785699" y="3412576"/>
            <a:ext cx="3337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3BFB3E9-43EE-A749-AFD2-587B0FCAB722}"/>
              </a:ext>
            </a:extLst>
          </p:cNvPr>
          <p:cNvSpPr txBox="1"/>
          <p:nvPr/>
        </p:nvSpPr>
        <p:spPr>
          <a:xfrm>
            <a:off x="2780349" y="4871596"/>
            <a:ext cx="3337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3FB240E6-5D19-9548-A8A7-048F913F720E}"/>
              </a:ext>
            </a:extLst>
          </p:cNvPr>
          <p:cNvSpPr/>
          <p:nvPr/>
        </p:nvSpPr>
        <p:spPr>
          <a:xfrm>
            <a:off x="5423027" y="3167406"/>
            <a:ext cx="329688" cy="12973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43E77329-BA10-6D4D-9B4F-D7162F8B8DCD}"/>
              </a:ext>
            </a:extLst>
          </p:cNvPr>
          <p:cNvSpPr/>
          <p:nvPr/>
        </p:nvSpPr>
        <p:spPr>
          <a:xfrm>
            <a:off x="5420765" y="1728287"/>
            <a:ext cx="329688" cy="12973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55B74735-51A5-4441-B351-59B91B8B3A57}"/>
              </a:ext>
            </a:extLst>
          </p:cNvPr>
          <p:cNvSpPr/>
          <p:nvPr/>
        </p:nvSpPr>
        <p:spPr>
          <a:xfrm>
            <a:off x="5353480" y="4674647"/>
            <a:ext cx="329688" cy="12973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D8FE29FC-295C-EB4D-A4CD-2BB1EB5F94E8}"/>
              </a:ext>
            </a:extLst>
          </p:cNvPr>
          <p:cNvSpPr/>
          <p:nvPr/>
        </p:nvSpPr>
        <p:spPr>
          <a:xfrm>
            <a:off x="5395495" y="6178633"/>
            <a:ext cx="329688" cy="12973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B037FC18-1BE7-2646-ACCF-A07C7DA4F679}"/>
              </a:ext>
            </a:extLst>
          </p:cNvPr>
          <p:cNvSpPr txBox="1"/>
          <p:nvPr/>
        </p:nvSpPr>
        <p:spPr>
          <a:xfrm>
            <a:off x="4647010" y="357627"/>
            <a:ext cx="3337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D876C4F0-5AE6-5949-BB72-A77C99487686}"/>
              </a:ext>
            </a:extLst>
          </p:cNvPr>
          <p:cNvSpPr txBox="1"/>
          <p:nvPr/>
        </p:nvSpPr>
        <p:spPr>
          <a:xfrm>
            <a:off x="6293085" y="363761"/>
            <a:ext cx="3337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D7509F1-2BDA-BC44-84ED-3A40B78E4F9A}"/>
              </a:ext>
            </a:extLst>
          </p:cNvPr>
          <p:cNvSpPr txBox="1"/>
          <p:nvPr/>
        </p:nvSpPr>
        <p:spPr>
          <a:xfrm>
            <a:off x="6293085" y="1847901"/>
            <a:ext cx="3337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CAFC2D4-74DB-E24E-8048-A16BF8D6ABAB}"/>
              </a:ext>
            </a:extLst>
          </p:cNvPr>
          <p:cNvSpPr txBox="1"/>
          <p:nvPr/>
        </p:nvSpPr>
        <p:spPr>
          <a:xfrm>
            <a:off x="4667048" y="1852338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03F85EBB-4432-6640-9EB5-24C0FD8C0A92}"/>
              </a:ext>
            </a:extLst>
          </p:cNvPr>
          <p:cNvSpPr txBox="1"/>
          <p:nvPr/>
        </p:nvSpPr>
        <p:spPr>
          <a:xfrm>
            <a:off x="6313123" y="3389513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070B97C-F428-2D49-BA9F-9C261F3DF293}"/>
              </a:ext>
            </a:extLst>
          </p:cNvPr>
          <p:cNvSpPr txBox="1"/>
          <p:nvPr/>
        </p:nvSpPr>
        <p:spPr>
          <a:xfrm>
            <a:off x="6313123" y="4992477"/>
            <a:ext cx="29367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43401801-2072-F44E-8730-E1CF8F64CF0D}"/>
              </a:ext>
            </a:extLst>
          </p:cNvPr>
          <p:cNvSpPr txBox="1"/>
          <p:nvPr/>
        </p:nvSpPr>
        <p:spPr>
          <a:xfrm>
            <a:off x="4647010" y="4934976"/>
            <a:ext cx="3337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B8C2ABA-D4E7-B145-AE6D-381D28DA5D92}"/>
              </a:ext>
            </a:extLst>
          </p:cNvPr>
          <p:cNvSpPr txBox="1"/>
          <p:nvPr/>
        </p:nvSpPr>
        <p:spPr>
          <a:xfrm>
            <a:off x="4647010" y="3334646"/>
            <a:ext cx="3337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ns</a:t>
            </a:r>
          </a:p>
        </p:txBody>
      </p:sp>
    </p:spTree>
    <p:extLst>
      <p:ext uri="{BB962C8B-B14F-4D97-AF65-F5344CB8AC3E}">
        <p14:creationId xmlns:p14="http://schemas.microsoft.com/office/powerpoint/2010/main" val="21024874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342149F5-73AA-A048-9783-C92D6BE20507}"/>
              </a:ext>
            </a:extLst>
          </p:cNvPr>
          <p:cNvSpPr txBox="1"/>
          <p:nvPr/>
        </p:nvSpPr>
        <p:spPr>
          <a:xfrm>
            <a:off x="472864" y="4983715"/>
            <a:ext cx="103339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7 Fig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otal variance of principal component (PC) analysis, K-means clustering optimization, PC score plots on MCF-7 and MDA-MB-231. Bar graphs showing total variance (%) of each principal components and scatter plots indicating total intra-cluster variation in function of number of clusters in MCF-7 (A no treatment and TAM) and MDA-MB-231 (B no treatment and TAM) datasets. 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7501C30-ABCC-DA48-9099-82C3B387575E}"/>
              </a:ext>
            </a:extLst>
          </p:cNvPr>
          <p:cNvSpPr txBox="1"/>
          <p:nvPr/>
        </p:nvSpPr>
        <p:spPr>
          <a:xfrm>
            <a:off x="2963606" y="312776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21" name="Picture 20">
            <a:extLst>
              <a:ext uri="{FF2B5EF4-FFF2-40B4-BE49-F238E27FC236}">
                <a16:creationId xmlns:a16="http://schemas.microsoft.com/office/drawing/2014/main" id="{40232CA8-63CC-2740-A261-8A704A07351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11914" r="25388"/>
          <a:stretch/>
        </p:blipFill>
        <p:spPr>
          <a:xfrm>
            <a:off x="6509181" y="774300"/>
            <a:ext cx="2323545" cy="1847189"/>
          </a:xfrm>
          <a:prstGeom prst="rect">
            <a:avLst/>
          </a:prstGeom>
        </p:spPr>
      </p:pic>
      <p:grpSp>
        <p:nvGrpSpPr>
          <p:cNvPr id="3" name="Group 2">
            <a:extLst>
              <a:ext uri="{FF2B5EF4-FFF2-40B4-BE49-F238E27FC236}">
                <a16:creationId xmlns:a16="http://schemas.microsoft.com/office/drawing/2014/main" id="{DCB5C84E-4E3D-E045-B483-CD6486316DDA}"/>
              </a:ext>
            </a:extLst>
          </p:cNvPr>
          <p:cNvGrpSpPr/>
          <p:nvPr/>
        </p:nvGrpSpPr>
        <p:grpSpPr>
          <a:xfrm>
            <a:off x="2963606" y="548476"/>
            <a:ext cx="5866864" cy="1874732"/>
            <a:chOff x="2963606" y="548476"/>
            <a:chExt cx="5866864" cy="1874732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E2CB925B-3D4F-C54D-A235-154017E44AF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2963606" y="699127"/>
              <a:ext cx="1994382" cy="1724081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B42CE8D3-BC26-5D45-BFD7-A2CFFE08112C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745901" y="644336"/>
              <a:ext cx="1954753" cy="1721554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B2F65F78-58E0-C645-9EBE-1F601201912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0155" r="54254" b="78824"/>
            <a:stretch/>
          </p:blipFill>
          <p:spPr>
            <a:xfrm>
              <a:off x="8128107" y="559270"/>
              <a:ext cx="655108" cy="442976"/>
            </a:xfrm>
            <a:prstGeom prst="rect">
              <a:avLst/>
            </a:prstGeom>
          </p:spPr>
        </p:pic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457167FD-530E-AF47-8C3B-CC9067D077B2}"/>
                </a:ext>
              </a:extLst>
            </p:cNvPr>
            <p:cNvGrpSpPr/>
            <p:nvPr/>
          </p:nvGrpSpPr>
          <p:grpSpPr>
            <a:xfrm>
              <a:off x="8262179" y="548476"/>
              <a:ext cx="568291" cy="396880"/>
              <a:chOff x="4775812" y="2493616"/>
              <a:chExt cx="356141" cy="248719"/>
            </a:xfrm>
          </p:grpSpPr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62EE92D4-179F-E44D-997F-0C5A5197F15D}"/>
                  </a:ext>
                </a:extLst>
              </p:cNvPr>
              <p:cNvSpPr/>
              <p:nvPr/>
            </p:nvSpPr>
            <p:spPr>
              <a:xfrm>
                <a:off x="4861244" y="2505446"/>
                <a:ext cx="218890" cy="2184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3200"/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B8EF8E4B-0405-FE46-9656-59505A9E98C5}"/>
                  </a:ext>
                </a:extLst>
              </p:cNvPr>
              <p:cNvSpPr txBox="1"/>
              <p:nvPr/>
            </p:nvSpPr>
            <p:spPr>
              <a:xfrm>
                <a:off x="4775812" y="2493616"/>
                <a:ext cx="356139" cy="1316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C1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5939D6E5-6A9F-F14F-9801-EFC2F10B581F}"/>
                  </a:ext>
                </a:extLst>
              </p:cNvPr>
              <p:cNvSpPr txBox="1"/>
              <p:nvPr/>
            </p:nvSpPr>
            <p:spPr>
              <a:xfrm>
                <a:off x="4775814" y="2610727"/>
                <a:ext cx="356139" cy="1316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C3</a:t>
                </a:r>
              </a:p>
            </p:txBody>
          </p:sp>
        </p:grpSp>
      </p:grpSp>
      <p:grpSp>
        <p:nvGrpSpPr>
          <p:cNvPr id="2" name="Group 1">
            <a:extLst>
              <a:ext uri="{FF2B5EF4-FFF2-40B4-BE49-F238E27FC236}">
                <a16:creationId xmlns:a16="http://schemas.microsoft.com/office/drawing/2014/main" id="{703AA39B-FD32-EC43-B235-AD42BEDCE374}"/>
              </a:ext>
            </a:extLst>
          </p:cNvPr>
          <p:cNvGrpSpPr/>
          <p:nvPr/>
        </p:nvGrpSpPr>
        <p:grpSpPr>
          <a:xfrm>
            <a:off x="2963606" y="2491888"/>
            <a:ext cx="5934259" cy="2079623"/>
            <a:chOff x="6087964" y="2549528"/>
            <a:chExt cx="5934259" cy="2079623"/>
          </a:xfrm>
        </p:grpSpPr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2F8A5A0D-52CC-4C40-A599-A5BEC7261FA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6087964" y="2664413"/>
              <a:ext cx="1991458" cy="1721554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3005E08E-8DB8-604F-A5EA-4A649B20837D}"/>
                </a:ext>
              </a:extLst>
            </p:cNvPr>
            <p:cNvPicPr>
              <a:picLocks noChangeAspect="1"/>
            </p:cNvPicPr>
            <p:nvPr/>
          </p:nvPicPr>
          <p:blipFill>
            <a:blip r:embed="rId7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7884474" y="2719203"/>
              <a:ext cx="1954752" cy="1721554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132B270B-53D2-734D-B6A3-C591E1A2CD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t="15312" r="26836"/>
            <a:stretch/>
          </p:blipFill>
          <p:spPr>
            <a:xfrm>
              <a:off x="9692994" y="2820245"/>
              <a:ext cx="2320722" cy="1808906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3FD4E991-DEAF-FD47-A79E-7CAA30A7D2A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 l="20155" r="54254" b="78824"/>
            <a:stretch/>
          </p:blipFill>
          <p:spPr>
            <a:xfrm>
              <a:off x="11310510" y="2569827"/>
              <a:ext cx="655108" cy="442976"/>
            </a:xfrm>
            <a:prstGeom prst="rect">
              <a:avLst/>
            </a:prstGeom>
          </p:spPr>
        </p:pic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899A00E6-2263-5345-922F-08F94DB874BB}"/>
                </a:ext>
              </a:extLst>
            </p:cNvPr>
            <p:cNvGrpSpPr/>
            <p:nvPr/>
          </p:nvGrpSpPr>
          <p:grpSpPr>
            <a:xfrm>
              <a:off x="11453934" y="2549528"/>
              <a:ext cx="568289" cy="396885"/>
              <a:chOff x="4780513" y="2479108"/>
              <a:chExt cx="356140" cy="248723"/>
            </a:xfrm>
          </p:grpSpPr>
          <p:sp>
            <p:nvSpPr>
              <p:cNvPr id="41" name="Rectangle 40">
                <a:extLst>
                  <a:ext uri="{FF2B5EF4-FFF2-40B4-BE49-F238E27FC236}">
                    <a16:creationId xmlns:a16="http://schemas.microsoft.com/office/drawing/2014/main" id="{2D3A2F1E-98F0-B44E-BCED-91BF5B6FE2B5}"/>
                  </a:ext>
                </a:extLst>
              </p:cNvPr>
              <p:cNvSpPr/>
              <p:nvPr/>
            </p:nvSpPr>
            <p:spPr>
              <a:xfrm>
                <a:off x="4861244" y="2505446"/>
                <a:ext cx="218890" cy="21845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3200"/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A781FF75-6BE3-B64B-9787-D77CC12EFA0A}"/>
                  </a:ext>
                </a:extLst>
              </p:cNvPr>
              <p:cNvSpPr txBox="1"/>
              <p:nvPr/>
            </p:nvSpPr>
            <p:spPr>
              <a:xfrm>
                <a:off x="4780513" y="2479108"/>
                <a:ext cx="356139" cy="1316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C1</a:t>
                </a:r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32CC18FA-0751-2943-9598-10CD2306241B}"/>
                  </a:ext>
                </a:extLst>
              </p:cNvPr>
              <p:cNvSpPr txBox="1"/>
              <p:nvPr/>
            </p:nvSpPr>
            <p:spPr>
              <a:xfrm>
                <a:off x="4780514" y="2596223"/>
                <a:ext cx="356139" cy="1316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PC2</a:t>
                </a:r>
              </a:p>
            </p:txBody>
          </p:sp>
        </p:grpSp>
      </p:grpSp>
      <p:sp>
        <p:nvSpPr>
          <p:cNvPr id="7" name="TextBox 6">
            <a:extLst>
              <a:ext uri="{FF2B5EF4-FFF2-40B4-BE49-F238E27FC236}">
                <a16:creationId xmlns:a16="http://schemas.microsoft.com/office/drawing/2014/main" id="{8C521C2E-2279-ED4E-AB9A-A980320B77E2}"/>
              </a:ext>
            </a:extLst>
          </p:cNvPr>
          <p:cNvSpPr txBox="1"/>
          <p:nvPr/>
        </p:nvSpPr>
        <p:spPr>
          <a:xfrm>
            <a:off x="2963606" y="2241776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7CCB3AC-263B-2845-AC56-E2A4F1B862DD}"/>
              </a:ext>
            </a:extLst>
          </p:cNvPr>
          <p:cNvSpPr txBox="1"/>
          <p:nvPr/>
        </p:nvSpPr>
        <p:spPr>
          <a:xfrm>
            <a:off x="0" y="0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charset="0"/>
                <a:ea typeface="Arial" charset="0"/>
                <a:cs typeface="Arial" charset="0"/>
              </a:rPr>
              <a:t>S7 Fig</a:t>
            </a:r>
          </a:p>
        </p:txBody>
      </p:sp>
    </p:spTree>
    <p:extLst>
      <p:ext uri="{BB962C8B-B14F-4D97-AF65-F5344CB8AC3E}">
        <p14:creationId xmlns:p14="http://schemas.microsoft.com/office/powerpoint/2010/main" val="174385078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51B9C4DC-28EE-1241-8339-46EFA365D9D7}"/>
              </a:ext>
            </a:extLst>
          </p:cNvPr>
          <p:cNvSpPr txBox="1"/>
          <p:nvPr/>
        </p:nvSpPr>
        <p:spPr>
          <a:xfrm>
            <a:off x="0" y="0"/>
            <a:ext cx="10125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S1 Table</a:t>
            </a:r>
          </a:p>
        </p:txBody>
      </p:sp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31A658EE-4DB9-5041-A529-40E4F56BE76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0026866"/>
              </p:ext>
            </p:extLst>
          </p:nvPr>
        </p:nvGraphicFramePr>
        <p:xfrm>
          <a:off x="1118330" y="1242360"/>
          <a:ext cx="9955339" cy="413217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478148">
                  <a:extLst>
                    <a:ext uri="{9D8B030D-6E8A-4147-A177-3AD203B41FA5}">
                      <a16:colId xmlns:a16="http://schemas.microsoft.com/office/drawing/2014/main" val="3613005968"/>
                    </a:ext>
                  </a:extLst>
                </a:gridCol>
                <a:gridCol w="1472184">
                  <a:extLst>
                    <a:ext uri="{9D8B030D-6E8A-4147-A177-3AD203B41FA5}">
                      <a16:colId xmlns:a16="http://schemas.microsoft.com/office/drawing/2014/main" val="2034704636"/>
                    </a:ext>
                  </a:extLst>
                </a:gridCol>
                <a:gridCol w="1865376">
                  <a:extLst>
                    <a:ext uri="{9D8B030D-6E8A-4147-A177-3AD203B41FA5}">
                      <a16:colId xmlns:a16="http://schemas.microsoft.com/office/drawing/2014/main" val="2488331027"/>
                    </a:ext>
                  </a:extLst>
                </a:gridCol>
                <a:gridCol w="5139631">
                  <a:extLst>
                    <a:ext uri="{9D8B030D-6E8A-4147-A177-3AD203B41FA5}">
                      <a16:colId xmlns:a16="http://schemas.microsoft.com/office/drawing/2014/main" val="4157742847"/>
                    </a:ext>
                  </a:extLst>
                </a:gridCol>
              </a:tblGrid>
              <a:tr h="423776"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 Statu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, HER2 Status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yp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166455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818-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ativ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ativ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 breas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890512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918-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ativ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ative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rmal breast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6978615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818-2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+</a:t>
                      </a:r>
                      <a:endParaRPr 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HER2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mph node infiltrated breast tumor, ypT2 (m), ypN3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984776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818-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+</a:t>
                      </a:r>
                      <a:endParaRPr 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HER2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asive ductal breast tumo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452168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17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+</a:t>
                      </a:r>
                      <a:endParaRPr 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R2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+</a:t>
                      </a:r>
                      <a:r>
                        <a:rPr lang="en-US" sz="16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PR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mph node infiltrated breast tumo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502751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18-1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+</a:t>
                      </a:r>
                      <a:endParaRPr 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</a:t>
                      </a:r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HER2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vasive ductal breast tumor, pT2 pN0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703875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1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+</a:t>
                      </a:r>
                      <a:endParaRPr 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R2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16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PR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+</a:t>
                      </a:r>
                      <a:endParaRPr 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mph node infiltrated breast tumor, T4b N1A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8181592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1191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+</a:t>
                      </a:r>
                      <a:endParaRPr 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R2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+</a:t>
                      </a:r>
                      <a:r>
                        <a:rPr lang="en-US" sz="16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PR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2(m) pN0 breast tumo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4948735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30116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+</a:t>
                      </a:r>
                      <a:endParaRPr 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R2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+</a:t>
                      </a:r>
                      <a:r>
                        <a:rPr lang="en-US" sz="16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PR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endParaRPr 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2 pN1a breast tumo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4450124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225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+</a:t>
                      </a:r>
                      <a:endParaRPr 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R2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</a:t>
                      </a:r>
                      <a:r>
                        <a:rPr lang="en-US" sz="16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PR</a:t>
                      </a:r>
                      <a:r>
                        <a:rPr lang="en-US" sz="16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+</a:t>
                      </a:r>
                      <a:endParaRPr lang="en-US" sz="16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16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ypT1a breast tumor</a:t>
                      </a: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49345311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7E6B4633-FDDD-F640-96D4-6159D92A775C}"/>
              </a:ext>
            </a:extLst>
          </p:cNvPr>
          <p:cNvSpPr txBox="1"/>
          <p:nvPr/>
        </p:nvSpPr>
        <p:spPr>
          <a:xfrm>
            <a:off x="240847" y="6001343"/>
            <a:ext cx="49724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1 Table. </a:t>
            </a:r>
            <a:r>
              <a:rPr lang="en-US" sz="1200" dirty="0">
                <a:latin typeface="Arial" charset="0"/>
                <a:ea typeface="Arial" charset="0"/>
                <a:cs typeface="Arial" charset="0"/>
              </a:rPr>
              <a:t>Primary breast tissue sample information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735983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F30654B9-1231-BC4F-BE57-44F37DC5E573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303846569"/>
              </p:ext>
            </p:extLst>
          </p:nvPr>
        </p:nvGraphicFramePr>
        <p:xfrm>
          <a:off x="1484525" y="459041"/>
          <a:ext cx="9770663" cy="56692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49736">
                  <a:extLst>
                    <a:ext uri="{9D8B030D-6E8A-4147-A177-3AD203B41FA5}">
                      <a16:colId xmlns:a16="http://schemas.microsoft.com/office/drawing/2014/main" val="3117509239"/>
                    </a:ext>
                  </a:extLst>
                </a:gridCol>
                <a:gridCol w="1640572">
                  <a:extLst>
                    <a:ext uri="{9D8B030D-6E8A-4147-A177-3AD203B41FA5}">
                      <a16:colId xmlns:a16="http://schemas.microsoft.com/office/drawing/2014/main" val="2781747431"/>
                    </a:ext>
                  </a:extLst>
                </a:gridCol>
                <a:gridCol w="1726166">
                  <a:extLst>
                    <a:ext uri="{9D8B030D-6E8A-4147-A177-3AD203B41FA5}">
                      <a16:colId xmlns:a16="http://schemas.microsoft.com/office/drawing/2014/main" val="1314670816"/>
                    </a:ext>
                  </a:extLst>
                </a:gridCol>
                <a:gridCol w="1840685">
                  <a:extLst>
                    <a:ext uri="{9D8B030D-6E8A-4147-A177-3AD203B41FA5}">
                      <a16:colId xmlns:a16="http://schemas.microsoft.com/office/drawing/2014/main" val="1727138667"/>
                    </a:ext>
                  </a:extLst>
                </a:gridCol>
                <a:gridCol w="1703448">
                  <a:extLst>
                    <a:ext uri="{9D8B030D-6E8A-4147-A177-3AD203B41FA5}">
                      <a16:colId xmlns:a16="http://schemas.microsoft.com/office/drawing/2014/main" val="2204474208"/>
                    </a:ext>
                  </a:extLst>
                </a:gridCol>
                <a:gridCol w="1710056">
                  <a:extLst>
                    <a:ext uri="{9D8B030D-6E8A-4147-A177-3AD203B41FA5}">
                      <a16:colId xmlns:a16="http://schemas.microsoft.com/office/drawing/2014/main" val="821056838"/>
                    </a:ext>
                  </a:extLst>
                </a:gridCol>
              </a:tblGrid>
              <a:tr h="277912"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Type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tein Targe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</a:t>
                      </a:r>
                    </a:p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2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M</a:t>
                      </a:r>
                    </a:p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US" sz="1200" b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μ</a:t>
                      </a:r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n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 value</a:t>
                      </a:r>
                    </a:p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g vs. TAM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atistical Tes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742499"/>
                  </a:ext>
                </a:extLst>
              </a:tr>
              <a:tr h="243655">
                <a:tc rowSpan="10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F-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6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3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604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227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0.1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10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n-Whitney Test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13276139"/>
                  </a:ext>
                </a:extLst>
              </a:tr>
              <a:tr h="243655">
                <a:tc vMerge="1">
                  <a:txBody>
                    <a:bodyPr/>
                    <a:lstStyle/>
                    <a:p>
                      <a:endParaRPr lang="en-US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1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38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4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65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0.1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67869775"/>
                  </a:ext>
                </a:extLst>
              </a:tr>
              <a:tr h="243655"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β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85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4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54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42673661"/>
                  </a:ext>
                </a:extLst>
              </a:tr>
              <a:tr h="243655">
                <a:tc vMerge="1">
                  <a:txBody>
                    <a:bodyPr/>
                    <a:lstStyle/>
                    <a:p>
                      <a:endParaRPr lang="en-US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GFR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7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32534031"/>
                  </a:ext>
                </a:extLst>
              </a:tr>
              <a:tr h="243655">
                <a:tc vMerge="1">
                  <a:txBody>
                    <a:bodyPr/>
                    <a:lstStyle/>
                    <a:p>
                      <a:endParaRPr lang="en-US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38 MAPK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1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285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3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483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9186396"/>
                  </a:ext>
                </a:extLst>
              </a:tr>
              <a:tr h="243655"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T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78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289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12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286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0.1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80884894"/>
                  </a:ext>
                </a:extLst>
              </a:tr>
              <a:tr h="243655"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JUN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4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86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238 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23701297"/>
                  </a:ext>
                </a:extLst>
              </a:tr>
              <a:tr h="243655"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lin A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2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2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30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26785798"/>
                  </a:ext>
                </a:extLst>
              </a:tr>
              <a:tr h="243655"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1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201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4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62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55667429"/>
                  </a:ext>
                </a:extLst>
              </a:tr>
              <a:tr h="243655"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1</a:t>
                      </a:r>
                      <a:endParaRPr lang="en-US" sz="120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3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41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17938361"/>
                  </a:ext>
                </a:extLst>
              </a:tr>
              <a:tr h="243655">
                <a:tc rowSpan="9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DA-MB-231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α4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6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36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54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09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3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9"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n-Whitney Test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6405386"/>
                  </a:ext>
                </a:extLst>
              </a:tr>
              <a:tr h="243655"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R-β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1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230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8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5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57963331"/>
                  </a:ext>
                </a:extLst>
              </a:tr>
              <a:tr h="243655">
                <a:tc vMerge="1">
                  <a:txBody>
                    <a:bodyPr/>
                    <a:lstStyle/>
                    <a:p>
                      <a:endParaRPr lang="en-US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GFR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7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7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</a:t>
                      </a: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3595034"/>
                  </a:ext>
                </a:extLst>
              </a:tr>
              <a:tr h="243655">
                <a:tc vMerge="1">
                  <a:txBody>
                    <a:bodyPr/>
                    <a:lstStyle/>
                    <a:p>
                      <a:endParaRPr lang="en-US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38 MAPK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7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864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67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240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86135692"/>
                  </a:ext>
                </a:extLst>
              </a:tr>
              <a:tr h="243655"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KT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3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499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3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49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7078451"/>
                  </a:ext>
                </a:extLst>
              </a:tr>
              <a:tr h="243655"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JUN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3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723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6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61 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15456896"/>
                  </a:ext>
                </a:extLst>
              </a:tr>
              <a:tr h="243655"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lin A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5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4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0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14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3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38080315"/>
                  </a:ext>
                </a:extLst>
              </a:tr>
              <a:tr h="243655"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S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3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610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6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113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01942664"/>
                  </a:ext>
                </a:extLst>
              </a:tr>
              <a:tr h="243655"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4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5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305</a:t>
                      </a:r>
                      <a:endParaRPr lang="en-US" sz="1200" baseline="300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62 x 10</a:t>
                      </a:r>
                      <a:r>
                        <a:rPr lang="en-US" sz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r>
                        <a:rPr lang="en-US" sz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, 282</a:t>
                      </a:r>
                      <a:endParaRPr 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97790398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6AEBCF5-1F0D-194A-A6F7-BE9A418505C0}"/>
              </a:ext>
            </a:extLst>
          </p:cNvPr>
          <p:cNvSpPr txBox="1"/>
          <p:nvPr/>
        </p:nvSpPr>
        <p:spPr>
          <a:xfrm>
            <a:off x="36705" y="0"/>
            <a:ext cx="101258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charset="0"/>
                <a:ea typeface="Arial" charset="0"/>
                <a:cs typeface="Arial" charset="0"/>
              </a:rPr>
              <a:t>S2 Table</a:t>
            </a:r>
            <a:endParaRPr lang="en-US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578CC99-4D7C-004B-AF0C-7D0978A92C85}"/>
              </a:ext>
            </a:extLst>
          </p:cNvPr>
          <p:cNvSpPr txBox="1"/>
          <p:nvPr/>
        </p:nvSpPr>
        <p:spPr>
          <a:xfrm>
            <a:off x="454516" y="6398959"/>
            <a:ext cx="70632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2 Table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AM effects on MCF-7 and MDA-MB-231 subpopulations expressing ER-α protein targets.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5599886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023</TotalTime>
  <Words>2065</Words>
  <Application>Microsoft Macintosh PowerPoint</Application>
  <PresentationFormat>Widescreen</PresentationFormat>
  <Paragraphs>333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OHN KIM</dc:creator>
  <cp:lastModifiedBy>JOHN KIM</cp:lastModifiedBy>
  <cp:revision>86</cp:revision>
  <cp:lastPrinted>2020-04-04T05:25:42Z</cp:lastPrinted>
  <dcterms:created xsi:type="dcterms:W3CDTF">2019-09-12T17:07:46Z</dcterms:created>
  <dcterms:modified xsi:type="dcterms:W3CDTF">2021-07-13T09:19:56Z</dcterms:modified>
</cp:coreProperties>
</file>